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0" d="100"/>
          <a:sy n="70" d="100"/>
        </p:scale>
        <p:origin x="-1086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C3C4F5-F52B-4AAB-8E21-AD0543D1316D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75E70-E485-470C-ACBB-628CB54D954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C3C4F5-F52B-4AAB-8E21-AD0543D1316D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75E70-E485-470C-ACBB-628CB54D954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C3C4F5-F52B-4AAB-8E21-AD0543D1316D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75E70-E485-470C-ACBB-628CB54D954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C3C4F5-F52B-4AAB-8E21-AD0543D1316D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75E70-E485-470C-ACBB-628CB54D954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C3C4F5-F52B-4AAB-8E21-AD0543D1316D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75E70-E485-470C-ACBB-628CB54D954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C3C4F5-F52B-4AAB-8E21-AD0543D1316D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75E70-E485-470C-ACBB-628CB54D954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C3C4F5-F52B-4AAB-8E21-AD0543D1316D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75E70-E485-470C-ACBB-628CB54D954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C3C4F5-F52B-4AAB-8E21-AD0543D1316D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75E70-E485-470C-ACBB-628CB54D954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C3C4F5-F52B-4AAB-8E21-AD0543D1316D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75E70-E485-470C-ACBB-628CB54D954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C3C4F5-F52B-4AAB-8E21-AD0543D1316D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75E70-E485-470C-ACBB-628CB54D954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C3C4F5-F52B-4AAB-8E21-AD0543D1316D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75E70-E485-470C-ACBB-628CB54D954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C3C4F5-F52B-4AAB-8E21-AD0543D1316D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075E70-E485-470C-ACBB-628CB54D9544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mailto:philip.roberts@ucr.edu" TargetMode="External"/><Relationship Id="rId2" Type="http://schemas.openxmlformats.org/officeDocument/2006/relationships/hyperlink" Target="mailto:timothy.close@ucr.edu" TargetMode="Externa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914400" y="1600200"/>
            <a:ext cx="7166449" cy="19389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Genetic Mapping, Synteny and Physical Location of Two Loci for </a:t>
            </a: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usarium oxysporum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f.sp. </a:t>
            </a: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tracheiphilum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Race 4 Resistance in Cowpea [</a:t>
            </a: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Vigna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unguiculata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(L.) </a:t>
            </a:r>
            <a:r>
              <a:rPr kumimoji="0" lang="en-US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Walp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]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Molecular Breeding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Authors and Affiliations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Marti O. Pottorff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1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Guojing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Li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2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Jeffery D. Ehlers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3,1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Timothy J. Close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1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and Philip A. Roberts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4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1 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Department of Botany &amp; Plant Sciences, University of California Riverside, Riverside, CA, U.S.A.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2 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Zhejiang Academy of Agricultural Sciences, Hangzhou, P.R. China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3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Bill &amp; Melinda Gates Foundation, Seattle, Washington, U.S.A.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4 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Department of Nematology, University of California Riverside, Riverside, CA, U.S.A.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orresponding author: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  <a:hlinkClick r:id="rId2"/>
              </a:rPr>
              <a:t>timothy.close@ucr.edu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nd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  <a:hlinkClick r:id="rId3"/>
              </a:rPr>
              <a:t>philip.roberts@ucr.edu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/>
        </p:nvGraphicFramePr>
        <p:xfrm>
          <a:off x="1524000" y="1582139"/>
          <a:ext cx="6096000" cy="3693721"/>
        </p:xfrm>
        <a:graphic>
          <a:graphicData uri="http://schemas.openxmlformats.org/drawingml/2006/table">
            <a:tbl>
              <a:tblPr/>
              <a:tblGrid>
                <a:gridCol w="266285"/>
                <a:gridCol w="347910"/>
                <a:gridCol w="414815"/>
                <a:gridCol w="330960"/>
                <a:gridCol w="266285"/>
                <a:gridCol w="266285"/>
                <a:gridCol w="347910"/>
                <a:gridCol w="414815"/>
                <a:gridCol w="347910"/>
                <a:gridCol w="299738"/>
                <a:gridCol w="361291"/>
                <a:gridCol w="441577"/>
                <a:gridCol w="560669"/>
                <a:gridCol w="370211"/>
                <a:gridCol w="1059339"/>
              </a:tblGrid>
              <a:tr h="246249">
                <a:tc gridSpan="15"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Online Resource 4 </a:t>
                      </a:r>
                      <a:r>
                        <a:rPr lang="en-US" sz="700" i="1">
                          <a:latin typeface="Times New Roman"/>
                          <a:ea typeface="Times New Roman"/>
                        </a:rPr>
                        <a:t>Fot4-2</a:t>
                      </a:r>
                      <a:r>
                        <a:rPr lang="en-US" sz="700">
                          <a:latin typeface="Times New Roman"/>
                          <a:ea typeface="Times New Roman"/>
                        </a:rPr>
                        <a:t> locus in the CB27 x 24-125B-1 and CB27 x IT82E-18/Big Buff populations, the cowpea consensus genetic map and the cowpea physical map.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23124">
                <a:tc gridSpan="5"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CB27 x 24-125B-1 genetic map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CB27 x IT82E-18/Big Buff genetic map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Cowpea consensus genetic map 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Cowpea physical map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2312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LG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cM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SNP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LOD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R</a:t>
                      </a:r>
                      <a:r>
                        <a:rPr lang="en-US" sz="700" baseline="30000">
                          <a:latin typeface="Times New Roman"/>
                          <a:ea typeface="Times New Roman"/>
                        </a:rPr>
                        <a:t>2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LG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cM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SNP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LOD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R</a:t>
                      </a:r>
                      <a:r>
                        <a:rPr lang="en-US" sz="700" baseline="30000">
                          <a:latin typeface="Times New Roman"/>
                          <a:ea typeface="Times New Roman"/>
                        </a:rPr>
                        <a:t>2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LG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cM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SNP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ontig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AC(s)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12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9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64.48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0953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8.18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39.1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85.13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0953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.6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7.4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3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64.44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0953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98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042B12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12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9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64.48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0604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8.18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39.1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N/A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3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64.78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0604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solidFill>
                          <a:srgbClr val="000000"/>
                        </a:solidFill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solidFill>
                          <a:srgbClr val="000000"/>
                        </a:solidFill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12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N/A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N/A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3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65.16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0444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solidFill>
                          <a:srgbClr val="000000"/>
                        </a:solidFill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solidFill>
                          <a:srgbClr val="000000"/>
                        </a:solidFill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12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N/A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N/A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3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65.16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1027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solidFill>
                          <a:srgbClr val="000000"/>
                        </a:solidFill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solidFill>
                          <a:srgbClr val="000000"/>
                        </a:solidFill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12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9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64.22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0400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8.18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39.1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N/A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3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65.51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0400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solidFill>
                          <a:srgbClr val="000000"/>
                        </a:solidFill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solidFill>
                          <a:srgbClr val="000000"/>
                        </a:solidFill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12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9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64.48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0139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8.18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39.1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77.54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0139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7.7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0.5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3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66.99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0139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36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080L05, CM027B20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12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N/A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N/A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3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66.99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0207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solidFill>
                          <a:srgbClr val="000000"/>
                        </a:solidFill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solidFill>
                          <a:srgbClr val="000000"/>
                        </a:solidFill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12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9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64.48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1369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8.18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39.1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77.54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1369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7.7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0.5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3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66.99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1369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solidFill>
                          <a:srgbClr val="000000"/>
                        </a:solidFill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solidFill>
                          <a:srgbClr val="000000"/>
                        </a:solidFill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12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N/A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77.23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0938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7.56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0.1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3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67.15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0938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solidFill>
                          <a:srgbClr val="000000"/>
                        </a:solidFill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solidFill>
                          <a:srgbClr val="000000"/>
                        </a:solidFill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12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9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64.48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0831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8.18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39.1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76.95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0831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8.16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1.5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3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67.55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0831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solidFill>
                          <a:srgbClr val="000000"/>
                        </a:solidFill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solidFill>
                          <a:srgbClr val="000000"/>
                        </a:solidFill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12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N/A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76.95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1075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8.16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1.5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3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68.17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1075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81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M008G11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12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N/A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N/A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3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68.49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1109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04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M005N24, CM029M15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12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N/A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N/A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3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70.89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1085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solidFill>
                          <a:srgbClr val="000000"/>
                        </a:solidFill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solidFill>
                          <a:srgbClr val="000000"/>
                        </a:solidFill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12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9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64.48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1087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8.18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39.1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73.18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1087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9.92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5.5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3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71.52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1087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solidFill>
                          <a:srgbClr val="000000"/>
                        </a:solidFill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solidFill>
                          <a:srgbClr val="000000"/>
                        </a:solidFill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12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N/A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72.80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0352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0.66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7.1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3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71.75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0352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94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M052M22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12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9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65.07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0380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8.18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39.1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N/A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3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73.42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0380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45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M045O05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12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9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65.07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0984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8.18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39.1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N/A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3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73.42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0984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45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M045O05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12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9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66.27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1162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8.18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39.1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N/A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3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73.79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1162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56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093M08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12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N/A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57.68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0345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4.33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2.1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3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77.55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0345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solidFill>
                          <a:srgbClr val="000000"/>
                        </a:solidFill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solidFill>
                          <a:srgbClr val="000000"/>
                        </a:solidFill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12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N/A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57.68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0964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4.33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2.1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3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77.55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0964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solidFill>
                          <a:srgbClr val="000000"/>
                        </a:solidFill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solidFill>
                          <a:srgbClr val="000000"/>
                        </a:solidFill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12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N/A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57.34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0718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4.8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3.3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3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77.55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0718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solidFill>
                          <a:srgbClr val="000000"/>
                        </a:solidFill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solidFill>
                          <a:srgbClr val="000000"/>
                        </a:solidFill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12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N/A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57.34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1452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4.8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3.3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3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77.55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1452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solidFill>
                          <a:srgbClr val="000000"/>
                        </a:solidFill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solidFill>
                          <a:srgbClr val="000000"/>
                        </a:solidFill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12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N/A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55.65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1015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3.33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9.4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3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78.71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1015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solidFill>
                          <a:srgbClr val="000000"/>
                        </a:solidFill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solidFill>
                          <a:srgbClr val="000000"/>
                        </a:solidFill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12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N/A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N/A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3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79.20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1513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solidFill>
                          <a:srgbClr val="000000"/>
                        </a:solidFill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solidFill>
                          <a:srgbClr val="000000"/>
                        </a:solidFill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12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N/A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N/A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3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79.86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1134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solidFill>
                          <a:srgbClr val="000000"/>
                        </a:solidFill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solidFill>
                          <a:srgbClr val="000000"/>
                        </a:solidFill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12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9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72.55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0594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8.49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40.2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 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 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N/A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 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>
                        <a:latin typeface="Times New Roman"/>
                        <a:ea typeface="Times New Roman"/>
                      </a:endParaRPr>
                    </a:p>
                  </a:txBody>
                  <a:tcPr marL="51302" marR="513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3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80.23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latin typeface="Times New Roman"/>
                          <a:ea typeface="Times New Roman"/>
                        </a:rPr>
                        <a:t>1_0594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lang="en-US" sz="80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lang="en-US" sz="800" dirty="0">
                        <a:latin typeface="Times New Roman"/>
                        <a:ea typeface="Calibri"/>
                      </a:endParaRPr>
                    </a:p>
                  </a:txBody>
                  <a:tcPr marL="51302" marR="513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30</Words>
  <Application>Microsoft Office PowerPoint</Application>
  <PresentationFormat>On-screen Show (4:3)</PresentationFormat>
  <Paragraphs>277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lide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rti</dc:creator>
  <cp:lastModifiedBy>Marti</cp:lastModifiedBy>
  <cp:revision>1</cp:revision>
  <dcterms:created xsi:type="dcterms:W3CDTF">2013-11-13T12:21:13Z</dcterms:created>
  <dcterms:modified xsi:type="dcterms:W3CDTF">2013-11-13T12:22:07Z</dcterms:modified>
</cp:coreProperties>
</file>